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35"/>
    <p:restoredTop sz="94637"/>
  </p:normalViewPr>
  <p:slideViewPr>
    <p:cSldViewPr snapToGrid="0">
      <p:cViewPr varScale="1">
        <p:scale>
          <a:sx n="51" d="100"/>
          <a:sy n="51" d="100"/>
        </p:scale>
        <p:origin x="200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2613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41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5944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97313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782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9406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24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295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0713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898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76577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0781E4-0EC7-974F-A1DD-4553BDB87601}" type="datetimeFigureOut">
              <a:rPr kumimoji="1" lang="ja-JP" altLang="en-US" smtClean="0"/>
              <a:t>2026/7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ACC55B-02B2-5746-A334-9B7D6D23A6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046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図 24">
            <a:extLst>
              <a:ext uri="{FF2B5EF4-FFF2-40B4-BE49-F238E27FC236}">
                <a16:creationId xmlns:a16="http://schemas.microsoft.com/office/drawing/2014/main" id="{EEE99252-2641-7D55-023D-4059329B83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1026"/>
            <a:ext cx="6858000" cy="3856279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6D2E3504-1085-4B95-CB25-69425241DEC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992122"/>
            <a:ext cx="6858000" cy="382755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9940278-A653-29F3-DBF8-B9381DAE4DC6}"/>
              </a:ext>
            </a:extLst>
          </p:cNvPr>
          <p:cNvSpPr txBox="1"/>
          <p:nvPr/>
        </p:nvSpPr>
        <p:spPr>
          <a:xfrm>
            <a:off x="278704" y="8116866"/>
            <a:ext cx="6300592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: Histogram and dot plot gating criteria for flow cytometry. The cell population that were negative in the PE-channel for the WBC antibody cocktail (CD34-, CD45-, CD11b-, CD19-, HLA-DR-) were used as the starting criteria and backgated in a serial fashion for CD73+ (WBC-, CD73+), to CD105+ (WBC-, CD73+, CD105+) to CD90+ (WBC-, CD73+, CD105+, CD90+). Similarly, the appropriate antibody isotypes were used to set initial gates for the CD45 and CD146 panel. The CD146+ population in the respective channel was backgated to the CD45- population 207 to determine the percent of CD45-/CD146+ cells.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545992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2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春来 西村</dc:creator>
  <cp:lastModifiedBy>MDPI</cp:lastModifiedBy>
  <cp:revision>2</cp:revision>
  <dcterms:created xsi:type="dcterms:W3CDTF">2026-07-07T03:19:55Z</dcterms:created>
  <dcterms:modified xsi:type="dcterms:W3CDTF">2026-07-10T08:14:34Z</dcterms:modified>
</cp:coreProperties>
</file>